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12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581" y="82"/>
      </p:cViewPr>
      <p:guideLst>
        <p:guide orient="horz" pos="141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Υπότιτλο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63664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22953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51380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92556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21014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περιεχομένου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03044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Θέση κειμένου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6" name="Θέση περιεχομένου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7" name="Θέση ημερομηνίας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8" name="Θέση υποσέλιδου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45221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4" name="Θέση υποσέλιδου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36089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3" name="Θέση υποσέλιδου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836750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967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εικόνας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70113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AC5E8-EA97-4FE6-A18D-39BF8F3F5EB9}" type="datetimeFigureOut">
              <a:rPr lang="el-GR" smtClean="0"/>
              <a:t>25/4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10F05-A06B-467A-993A-584FF3A44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90040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807464" y="3822192"/>
            <a:ext cx="857707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1.</a:t>
            </a:r>
            <a:r>
              <a:rPr lang="en-US" dirty="0" smtClean="0"/>
              <a:t> Results of RT-</a:t>
            </a:r>
            <a:r>
              <a:rPr lang="en-US" dirty="0" err="1" smtClean="0"/>
              <a:t>PCR</a:t>
            </a:r>
            <a:r>
              <a:rPr lang="en-US" dirty="0" smtClean="0"/>
              <a:t> tests of olive plants grafted with olive virus </a:t>
            </a:r>
            <a:r>
              <a:rPr lang="en-US" smtClean="0"/>
              <a:t>T </a:t>
            </a:r>
            <a:r>
              <a:rPr lang="en-US"/>
              <a:t>infected </a:t>
            </a:r>
            <a:r>
              <a:rPr lang="en-US" smtClean="0"/>
              <a:t>scions (</a:t>
            </a:r>
            <a:r>
              <a:rPr lang="en-US"/>
              <a:t>lane </a:t>
            </a:r>
            <a:r>
              <a:rPr lang="en-US" dirty="0" smtClean="0"/>
              <a:t>1: 100bp ladder; lane 2: negative control; lane 3: positive control, lanes 4-8: positive samples; lane 9-11: negative samples)</a:t>
            </a:r>
            <a:endParaRPr lang="el-GR" dirty="0"/>
          </a:p>
        </p:txBody>
      </p:sp>
      <p:grpSp>
        <p:nvGrpSpPr>
          <p:cNvPr id="17" name="Ομάδα 16"/>
          <p:cNvGrpSpPr/>
          <p:nvPr/>
        </p:nvGrpSpPr>
        <p:grpSpPr>
          <a:xfrm>
            <a:off x="3112008" y="2011137"/>
            <a:ext cx="5401056" cy="1570263"/>
            <a:chOff x="3112008" y="2011137"/>
            <a:chExt cx="5401056" cy="1570263"/>
          </a:xfrm>
        </p:grpSpPr>
        <p:pic>
          <p:nvPicPr>
            <p:cNvPr id="2" name="Εικόνα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12008" y="2014728"/>
              <a:ext cx="5401056" cy="1566672"/>
            </a:xfrm>
            <a:prstGeom prst="rect">
              <a:avLst/>
            </a:prstGeom>
          </p:spPr>
        </p:pic>
        <p:grpSp>
          <p:nvGrpSpPr>
            <p:cNvPr id="4" name="Ομάδα 3"/>
            <p:cNvGrpSpPr/>
            <p:nvPr/>
          </p:nvGrpSpPr>
          <p:grpSpPr>
            <a:xfrm>
              <a:off x="3112008" y="2011137"/>
              <a:ext cx="5378800" cy="311368"/>
              <a:chOff x="3112008" y="2011137"/>
              <a:chExt cx="5378800" cy="311368"/>
            </a:xfrm>
          </p:grpSpPr>
          <p:sp>
            <p:nvSpPr>
              <p:cNvPr id="3" name="TextBox 2"/>
              <p:cNvSpPr txBox="1"/>
              <p:nvPr/>
            </p:nvSpPr>
            <p:spPr>
              <a:xfrm>
                <a:off x="3112008" y="2014728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1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520402" y="2014266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3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4084647" y="2014672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2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965192" y="2013930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4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5891781" y="2013681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6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432712" y="2014000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5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6341952" y="2012193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7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6763294" y="2011137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8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7214148" y="2014068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9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7656703" y="2014065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10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8064088" y="2014060"/>
                <a:ext cx="4267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solidFill>
                      <a:schemeClr val="bg1"/>
                    </a:solidFill>
                  </a:rPr>
                  <a:t>11</a:t>
                </a:r>
                <a:endParaRPr lang="el-GR" sz="1400" dirty="0">
                  <a:solidFill>
                    <a:schemeClr val="bg1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30121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7</TotalTime>
  <Words>59</Words>
  <Application>Microsoft Office PowerPoint</Application>
  <PresentationFormat>Ευρεία οθόνη</PresentationFormat>
  <Paragraphs>12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CHATZIVASSILIOU Elisavet</dc:creator>
  <cp:lastModifiedBy>CHATZIVASSILIOU Elisavet</cp:lastModifiedBy>
  <cp:revision>10</cp:revision>
  <dcterms:created xsi:type="dcterms:W3CDTF">2021-04-25T13:55:48Z</dcterms:created>
  <dcterms:modified xsi:type="dcterms:W3CDTF">2021-04-25T18:34:43Z</dcterms:modified>
</cp:coreProperties>
</file>